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0" r:id="rId2"/>
  </p:sldIdLst>
  <p:sldSz cx="12192000" cy="6858000"/>
  <p:notesSz cx="9923463" cy="67945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cientific Editor" initials="SE" lastIdx="9" clrIdx="0">
    <p:extLst>
      <p:ext uri="{19B8F6BF-5375-455C-9EA6-DF929625EA0E}">
        <p15:presenceInfo xmlns:p15="http://schemas.microsoft.com/office/powerpoint/2012/main" userId="Scientific Editor" providerId="None"/>
      </p:ext>
    </p:extLst>
  </p:cmAuthor>
  <p:cmAuthor id="2" name="takesue" initials="t" lastIdx="5" clrIdx="1">
    <p:extLst>
      <p:ext uri="{19B8F6BF-5375-455C-9EA6-DF929625EA0E}">
        <p15:presenceInfo xmlns:p15="http://schemas.microsoft.com/office/powerpoint/2012/main" userId="takesu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6426" autoAdjust="0"/>
    <p:restoredTop sz="95529" autoAdjust="0"/>
  </p:normalViewPr>
  <p:slideViewPr>
    <p:cSldViewPr snapToGrid="0">
      <p:cViewPr varScale="1">
        <p:scale>
          <a:sx n="110" d="100"/>
          <a:sy n="110" d="100"/>
        </p:scale>
        <p:origin x="1044" y="10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1127" y="0"/>
            <a:ext cx="4300749" cy="341154"/>
          </a:xfrm>
          <a:prstGeom prst="rect">
            <a:avLst/>
          </a:prstGeom>
        </p:spPr>
        <p:txBody>
          <a:bodyPr vert="horz" lIns="91403" tIns="45702" rIns="91403" bIns="45702" rtlCol="0"/>
          <a:lstStyle>
            <a:lvl1pPr algn="r">
              <a:defRPr sz="1200"/>
            </a:lvl1pPr>
          </a:lstStyle>
          <a:p>
            <a:fld id="{EE51A95F-65DE-4144-A4F9-634112008E7B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924175" y="849313"/>
            <a:ext cx="4075113" cy="22923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3" tIns="45702" rIns="91403" bIns="4570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1871" y="3270310"/>
            <a:ext cx="7939722" cy="2675275"/>
          </a:xfrm>
          <a:prstGeom prst="rect">
            <a:avLst/>
          </a:prstGeom>
        </p:spPr>
        <p:txBody>
          <a:bodyPr vert="horz" lIns="91403" tIns="45702" rIns="91403" bIns="4570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1127" y="6453347"/>
            <a:ext cx="4300749" cy="341153"/>
          </a:xfrm>
          <a:prstGeom prst="rect">
            <a:avLst/>
          </a:prstGeom>
        </p:spPr>
        <p:txBody>
          <a:bodyPr vert="horz" lIns="91403" tIns="45702" rIns="91403" bIns="45702" rtlCol="0" anchor="b"/>
          <a:lstStyle>
            <a:lvl1pPr algn="r">
              <a:defRPr sz="1200"/>
            </a:lvl1pPr>
          </a:lstStyle>
          <a:p>
            <a:fld id="{E3776AED-F714-4E36-B15F-2F7F9B335F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8795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B805445-C5E7-8F3D-996C-AD90650695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4C033B15-A4F8-6D06-28C0-1A2D4026D0F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FC87F14-493E-DD58-B161-EC24192C32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0D18E99-8411-65B0-2E48-739DF1C67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733CEF5-EDC4-F417-EB78-DBB057DC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79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698543-C304-D1F8-0D6B-FCEE7567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3D4BEDC-5958-8A32-4BEA-4DA0480924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3837EBE-E13E-9DBC-A607-854C2B8E80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FEC844-3CE3-9E1D-561F-65256E043E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64862CB-AE89-F53E-CBE6-C527B6EAF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3486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DADB-12FE-172E-9244-A8BB8E99190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EABBDB-F138-6847-CA5E-7DA0EEDFE66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FE7E1F-CA43-EFBF-947E-7C9267F867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80C432C-E29E-D3B8-AC56-E06F829D8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37A043-6A8F-6554-056F-723521569C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1750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BDA391-41BC-8784-7F50-698A57A03A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3A5739D-C5BA-22E2-8E9D-19F595042A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B5F3F2A-9A84-A233-AFFF-DBD8EA2FA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B273A7-8C01-0B32-D927-A54EF5188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9BCC30-51BC-9E5D-64E0-C4186E67D6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1173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23F1CD6-FEC7-E737-0A7C-5654D4C489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AD5CB1A-09A0-9161-A4F9-739111FAE1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D679982-F495-7293-9420-80801866D5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CDE3FD-03DF-33F6-1DE8-EADC8FA5C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6B58B4-D4A8-D28F-7E00-2CE7DA7DCC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5671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7BC8D-CC93-E33B-79AE-AE2CAB14D0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80143E3-8DA8-1924-1FB4-70E81399409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CCBCFA5-4794-6D86-5232-F3142F5158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349ED8-6BCD-343D-89CE-6CA4BDD8BC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295D9E-3042-EBF9-590C-6D15DB1541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51B38AD-51DE-5A12-AB13-DA2E1E5A6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65517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42AD5B5-0AA4-B54A-EDA9-C4F15B3F93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6A8EF41-E38C-25BA-18EB-2E978FF3E6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B557007-AEFF-29F5-5185-6F3687C24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7DF7C524-F2E7-4F44-4D91-41A1D72A65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580C3B5-1FC5-8827-E67A-7137A7D5CF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9EBC0B17-37D0-6804-2642-F85E21268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486DB4C3-D99D-66C0-9B9B-7EA3BE896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0B1387E-978A-9A80-E28C-E0F9DA3FEA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786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D41263-06DA-4F04-E1D6-77EDC95136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D4832DD-62AD-81AE-42D3-F0B25D395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0E13C27-E914-7074-876C-16E94812D4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8DAA2339-A053-13A5-6AD4-BAABA00700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3187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7D530694-D296-03C8-F4D5-9DE351A669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9C64E79D-6A5C-CA72-C94F-A3E2C1A157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DC5F7FD-D4BD-6C5B-5194-1AC3EB42B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750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7B202E-6E1B-BDF9-F7FF-9AA9328D8B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4529CAD-7770-44A5-00AB-2C3B356EF0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DD6EE63-BE28-B8D0-57AA-064197EAFF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AB4F50D-30FD-EA7E-FAC9-5E56B933B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FB0D5C2-601D-5FC0-FD06-9A6D0E8EB2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695EBB8-A87D-5FCB-95D4-897BD1E313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178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5901B9-027C-8CF8-B66F-D01D5AE3F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A623BA3-F2C7-E504-C748-B839E2523B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A07837E-40DB-31B6-5C90-5B263A64C1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B9F8B2-5AB9-899D-82E7-2F246515C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567CE2C-2F2C-11FE-EE36-C155014E7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35A3879-3D86-6ED3-0BAB-F98B80C0F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5547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F2BFEDC-5E77-D0D7-D3FE-0DA0E0ECB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756CCB6-60C8-67B7-381C-B0006635C9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742A2E9-A0C1-0081-604B-10C2D16DA7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9BB2F-FF39-4E29-99C2-7B33A3517908}" type="datetimeFigureOut">
              <a:rPr kumimoji="1" lang="ja-JP" altLang="en-US" smtClean="0"/>
              <a:t>2023/4/1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7C0A2F7-0AAA-B474-9AF4-84E6FCE3F36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E183C30-2FBD-BC16-D0CC-FF7480F55E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355FD-AC4B-44D3-8BA8-93BFA3AE574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895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コンテンツ プレースホルダー 3">
            <a:extLst>
              <a:ext uri="{FF2B5EF4-FFF2-40B4-BE49-F238E27FC236}">
                <a16:creationId xmlns:a16="http://schemas.microsoft.com/office/drawing/2014/main" id="{77422826-1551-45D2-A21D-4C102C83F661}"/>
              </a:ext>
            </a:extLst>
          </p:cNvPr>
          <p:cNvGraphicFramePr>
            <a:graphicFrameLocks noGrp="1"/>
          </p:cNvGraphicFramePr>
          <p:nvPr>
            <p:ph idx="1"/>
          </p:nvPr>
        </p:nvGraphicFramePr>
        <p:xfrm>
          <a:off x="325734" y="1690688"/>
          <a:ext cx="11229870" cy="3418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4963">
                  <a:extLst>
                    <a:ext uri="{9D8B030D-6E8A-4147-A177-3AD203B41FA5}">
                      <a16:colId xmlns:a16="http://schemas.microsoft.com/office/drawing/2014/main" val="1559176575"/>
                    </a:ext>
                  </a:extLst>
                </a:gridCol>
                <a:gridCol w="2392987">
                  <a:extLst>
                    <a:ext uri="{9D8B030D-6E8A-4147-A177-3AD203B41FA5}">
                      <a16:colId xmlns:a16="http://schemas.microsoft.com/office/drawing/2014/main" val="1144842437"/>
                    </a:ext>
                  </a:extLst>
                </a:gridCol>
                <a:gridCol w="3079098">
                  <a:extLst>
                    <a:ext uri="{9D8B030D-6E8A-4147-A177-3AD203B41FA5}">
                      <a16:colId xmlns:a16="http://schemas.microsoft.com/office/drawing/2014/main" val="1091696254"/>
                    </a:ext>
                  </a:extLst>
                </a:gridCol>
                <a:gridCol w="3327240">
                  <a:extLst>
                    <a:ext uri="{9D8B030D-6E8A-4147-A177-3AD203B41FA5}">
                      <a16:colId xmlns:a16="http://schemas.microsoft.com/office/drawing/2014/main" val="2035972759"/>
                    </a:ext>
                  </a:extLst>
                </a:gridCol>
                <a:gridCol w="1415582">
                  <a:extLst>
                    <a:ext uri="{9D8B030D-6E8A-4147-A177-3AD203B41FA5}">
                      <a16:colId xmlns:a16="http://schemas.microsoft.com/office/drawing/2014/main" val="3729133701"/>
                    </a:ext>
                  </a:extLst>
                </a:gridCol>
              </a:tblGrid>
              <a:tr h="370840">
                <a:tc gridSpan="2"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kers of antibiotic use</a:t>
                      </a:r>
                      <a:r>
                        <a:rPr kumimoji="1" lang="ja-JP" altLang="en-US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ril 2021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March 2022, 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 1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pril 2022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–September 2022, term 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value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3372615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 DOT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0 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±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.50</a:t>
                      </a:r>
                      <a:endParaRPr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85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96</a:t>
                      </a:r>
                      <a:endParaRPr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49</a:t>
                      </a:r>
                      <a:endParaRPr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07895542"/>
                  </a:ext>
                </a:extLst>
              </a:tr>
              <a:tr h="370840">
                <a:tc rowSpan="4">
                  <a:txBody>
                    <a:bodyPr/>
                    <a:lstStyle/>
                    <a:p>
                      <a:pPr algn="ctr"/>
                      <a:r>
                        <a:rPr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lative DOT, %</a:t>
                      </a:r>
                      <a:endParaRPr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iperacillin/tazobactam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81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5.13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.27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63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14478142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ja-JP" altLang="en-US"/>
                    </a:p>
                  </a:txBody>
                  <a:tcPr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urth-generation cephalosporins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, ceftazidime,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ztreonam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29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8.19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.33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7.22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3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7718955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ja-JP" altLang="en-US"/>
                    </a:p>
                  </a:txBody>
                  <a:tcPr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rbapenems 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.06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12.61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53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9.98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9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25441187"/>
                  </a:ext>
                </a:extLst>
              </a:tr>
              <a:tr h="370840">
                <a:tc vMerge="1"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uoroquinolones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5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5.91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0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2.30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49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33871634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HI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69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148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76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076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44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4823371"/>
                  </a:ext>
                </a:extLst>
              </a:tr>
              <a:tr h="370840">
                <a:tc gridSpan="2"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odified AHI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ja-JP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Yu Gothic" panose="020B0400000000000000" pitchFamily="50" charset="-128"/>
                          <a:cs typeface="Times New Roman" panose="02020603050405020304" pitchFamily="18" charset="0"/>
                        </a:rPr>
                        <a:t>0.665 ± 0.137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24 </a:t>
                      </a:r>
                      <a:r>
                        <a:rPr kumimoji="1" lang="en-US" altLang="ja-JP" sz="16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0.115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4</a:t>
                      </a:r>
                      <a:endParaRPr kumimoji="1" lang="ja-JP" altLang="en-US" sz="1600" b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56419515"/>
                  </a:ext>
                </a:extLst>
              </a:tr>
            </a:tbl>
          </a:graphicData>
        </a:graphic>
      </p:graphicFrame>
      <p:sp>
        <p:nvSpPr>
          <p:cNvPr id="5" name="タイトル 1">
            <a:extLst>
              <a:ext uri="{FF2B5EF4-FFF2-40B4-BE49-F238E27FC236}">
                <a16:creationId xmlns:a16="http://schemas.microsoft.com/office/drawing/2014/main" id="{FCFAD48E-23F6-4E31-B1AB-256AB48689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</p:spPr>
        <p:txBody>
          <a:bodyPr>
            <a:no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6 </a:t>
            </a:r>
            <a:r>
              <a:rPr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ys of therapy (DOT) and relative DOT and antibiotic heterogeneity indices (AHIs) for broad-spectrum antibiotics commonly used for hospital-onset infections on the acute-phase medical wards in the community hospital</a:t>
            </a:r>
            <a:r>
              <a:rPr lang="hu-HU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ja-JP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141636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30</TotalTime>
  <Words>127</Words>
  <Application>Microsoft Office PowerPoint</Application>
  <PresentationFormat>ワイド画面</PresentationFormat>
  <Paragraphs>3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S6 Table. Days of therapy (DOT) and relative DOT and antibiotic heterogeneity indices (AHIs) for broad-spectrum antibiotics commonly used for hospital-onset infections on the acute-phase medical wards in the community hospital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_Mente</dc:creator>
  <cp:lastModifiedBy>植田貴史</cp:lastModifiedBy>
  <cp:revision>312</cp:revision>
  <cp:lastPrinted>2023-04-12T10:42:11Z</cp:lastPrinted>
  <dcterms:created xsi:type="dcterms:W3CDTF">2022-09-14T02:01:21Z</dcterms:created>
  <dcterms:modified xsi:type="dcterms:W3CDTF">2023-04-12T10:45:06Z</dcterms:modified>
</cp:coreProperties>
</file>